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94" d="100"/>
          <a:sy n="94" d="100"/>
        </p:scale>
        <p:origin x="8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8F84BD-2650-FEDA-22EF-6741541A23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4730ECE-3145-5A28-4722-2F6419EDAA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C60E5E-2A78-C366-910D-23B834244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A8A811-F044-2E20-DDCF-413405081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7F58AF-3C48-361E-F93B-FD09F33F6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0725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251D6F-8A68-A64D-1ABA-EE109BAA35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A295B67-F52D-2854-AC7C-DCB183D420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165207-5087-734C-5BF3-AB10B4188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C769AB-2872-5240-15F6-A0261F1B9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488C26-2235-3633-F050-C59C13E95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6141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0636933-B311-EFB7-B102-F5A43CBCD8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3B0BBDF-26AF-0BA3-2C78-7CCC5CF841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20CD3F-C652-55C0-A919-C59F96E4E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B05329-7B8C-5022-8E42-F9F3C8A3C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D3C990-D70A-B0C4-C43D-12DCDDEAC6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8394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4CCB19-80FF-CA7D-4F83-35DEFCD8E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62DCFB5-1CCA-9067-3679-261F485CFF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D5C452D-A180-5B6A-13F8-F3871DB10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7DD25D-5569-5E21-DD43-86065AC57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5FFC9E-0192-EEDA-7131-6C3DD7E55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321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2362D5-1DB2-6C32-B65B-B2C0E9076E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EF6D34-DFFC-AA26-26E8-40D3741677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BC7DE3-DAFE-256D-E881-A3219E8CF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288E43-5145-788A-DEC0-E3FE59F4E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526383-FD48-A4D0-05D5-7979789D4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6230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F69CCD-9892-AED1-8398-072C7518C7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3204EC7-80B0-1532-7379-F520DAC3C2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1DC214E-69BA-5191-3692-6F76490BEC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739F242-3716-1CC4-7415-482CF9580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DF0B897-A45B-BA33-8740-89F71722C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6EA2445-623D-762E-C77C-911970794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4432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A4C722-4E54-AB3A-7ECF-DB58D6B30B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3965565-6CF7-7122-6D73-7AFDCBDBCB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A3CB4D5-7317-85CD-D76E-027070AEFA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EC8C2C4-C493-7D1F-36B1-7A26DB1842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C09405E-AC12-583B-B386-59E3E572EF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CED1673-9828-7210-082B-D69A697E4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A6FB216-B7FB-8597-17F9-EA301087B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953FBAC-0159-1E50-2DCE-D22B8F6C3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179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06E00C-CEF1-EE42-AEAA-027A63EE99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13D31B7-A4CF-7CB5-A5AD-1E3BF3745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472EA7B-3B5C-9B65-77C3-CDCDCABCB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D9298BF-5BF8-2302-DDAB-4B64E9DE2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8437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C336915-0204-3435-44F9-70614C2A7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112357A-2597-3ED1-5BFB-10263D5EE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B77B843-BC4B-C3D0-9FF6-2FA7A3B95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0457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183C11-AF00-345E-E54A-EED6818A7C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764187B-2D0B-C5C7-2757-453F597E07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18935C5-F823-9F72-A654-E5B2DC4F8C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54D471-4315-B48F-B045-1CAD8083F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24E067C-F7FE-98AA-A17E-211C3B541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0EEF511-B6F8-89DC-622F-C2474F43A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295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A5F305-09C4-61E8-2B41-7E6C4BC30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5010512-134C-AC82-ECFB-46A6036FAF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D1B6944-22D7-6D5F-A6B5-63B5E8ACA8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255669A-027B-51D4-5A88-50CA1576C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FAAFD56-874A-1243-7742-38A11FF51C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BA1B37A-7D82-1510-63A2-8340E5B96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165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2923BEF-82B9-13C8-659B-FEB1B9587A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D65B4A-7026-7BA1-57CB-0CE14AE0E3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17CC1E-1D9E-D50E-4726-BC74504B6F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79DEF-B64D-4846-929F-2DA42E3C5245}" type="datetimeFigureOut">
              <a:rPr kumimoji="1" lang="ja-JP" altLang="en-US" smtClean="0"/>
              <a:t>2024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F900ED-4A9F-31A8-FA7B-C4BCE86D1C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67E5DB-D526-EE01-5CCE-CF56DD46A0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A0E63-2073-4F40-AB2D-04BA488DE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166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9A3767C-524D-3CC5-BE5F-C8BDBD882CF6}"/>
              </a:ext>
            </a:extLst>
          </p:cNvPr>
          <p:cNvSpPr txBox="1"/>
          <p:nvPr/>
        </p:nvSpPr>
        <p:spPr>
          <a:xfrm>
            <a:off x="6498523" y="4550032"/>
            <a:ext cx="3167541" cy="83099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Relapse without OP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50</a:t>
            </a:r>
            <a:r>
              <a:rPr kumimoji="1"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r>
              <a:rPr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atient</a:t>
            </a:r>
            <a:r>
              <a:rPr kumimoji="1"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 (55.0%)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79EBAFB-96AA-6EF7-2551-0A7A8530584A}"/>
              </a:ext>
            </a:extLst>
          </p:cNvPr>
          <p:cNvSpPr txBox="1"/>
          <p:nvPr/>
        </p:nvSpPr>
        <p:spPr>
          <a:xfrm>
            <a:off x="3593989" y="624436"/>
            <a:ext cx="4233697" cy="83099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Patients treated after OP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100 patients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E066C9D-22F4-F465-B670-BE032B17D0C5}"/>
              </a:ext>
            </a:extLst>
          </p:cNvPr>
          <p:cNvSpPr txBox="1"/>
          <p:nvPr/>
        </p:nvSpPr>
        <p:spPr>
          <a:xfrm>
            <a:off x="3831077" y="2601364"/>
            <a:ext cx="3679152" cy="83099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Relapse after treatment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6 patients</a:t>
            </a:r>
          </a:p>
        </p:txBody>
      </p:sp>
      <p:sp>
        <p:nvSpPr>
          <p:cNvPr id="7" name="矢印: 右 6">
            <a:extLst>
              <a:ext uri="{FF2B5EF4-FFF2-40B4-BE49-F238E27FC236}">
                <a16:creationId xmlns:a16="http://schemas.microsoft.com/office/drawing/2014/main" id="{8EA9080F-EA64-E397-CDED-400A548187C5}"/>
              </a:ext>
            </a:extLst>
          </p:cNvPr>
          <p:cNvSpPr/>
          <p:nvPr/>
        </p:nvSpPr>
        <p:spPr>
          <a:xfrm>
            <a:off x="5961231" y="1929909"/>
            <a:ext cx="356153" cy="18090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2CA4907-6395-2D76-E315-DC222556BCDB}"/>
              </a:ext>
            </a:extLst>
          </p:cNvPr>
          <p:cNvSpPr txBox="1"/>
          <p:nvPr/>
        </p:nvSpPr>
        <p:spPr>
          <a:xfrm>
            <a:off x="1713654" y="4538045"/>
            <a:ext cx="3854724" cy="83099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Relapse with repeat OP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36</a:t>
            </a:r>
            <a:r>
              <a:rPr kumimoji="1"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patients (</a:t>
            </a:r>
            <a:r>
              <a:rPr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45</a:t>
            </a:r>
            <a:r>
              <a:rPr kumimoji="1" lang="en-US" altLang="ja-JP" sz="24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.0%)</a:t>
            </a:r>
          </a:p>
        </p:txBody>
      </p:sp>
      <p:sp>
        <p:nvSpPr>
          <p:cNvPr id="9" name="矢印: 右 8">
            <a:extLst>
              <a:ext uri="{FF2B5EF4-FFF2-40B4-BE49-F238E27FC236}">
                <a16:creationId xmlns:a16="http://schemas.microsoft.com/office/drawing/2014/main" id="{3296A6D9-20CC-2C0F-1565-EAE97A82D227}"/>
              </a:ext>
            </a:extLst>
          </p:cNvPr>
          <p:cNvSpPr/>
          <p:nvPr/>
        </p:nvSpPr>
        <p:spPr>
          <a:xfrm rot="5400000">
            <a:off x="5222790" y="1772007"/>
            <a:ext cx="830998" cy="50592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F79ED98-6C40-8736-B604-0FEA901882BE}"/>
              </a:ext>
            </a:extLst>
          </p:cNvPr>
          <p:cNvSpPr txBox="1"/>
          <p:nvPr/>
        </p:nvSpPr>
        <p:spPr>
          <a:xfrm>
            <a:off x="6393694" y="1630848"/>
            <a:ext cx="5517359" cy="83099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progression: 12 p</a:t>
            </a:r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tients</a:t>
            </a:r>
          </a:p>
          <a:p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Lost follow-up: 2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矢印: 右 10">
            <a:extLst>
              <a:ext uri="{FF2B5EF4-FFF2-40B4-BE49-F238E27FC236}">
                <a16:creationId xmlns:a16="http://schemas.microsoft.com/office/drawing/2014/main" id="{0198F623-49A3-8D15-075D-AFA9860FF6A3}"/>
              </a:ext>
            </a:extLst>
          </p:cNvPr>
          <p:cNvSpPr/>
          <p:nvPr/>
        </p:nvSpPr>
        <p:spPr>
          <a:xfrm rot="8267833">
            <a:off x="4384008" y="3732240"/>
            <a:ext cx="830998" cy="50592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2" name="矢印: 右 11">
            <a:extLst>
              <a:ext uri="{FF2B5EF4-FFF2-40B4-BE49-F238E27FC236}">
                <a16:creationId xmlns:a16="http://schemas.microsoft.com/office/drawing/2014/main" id="{6F668D21-6DDF-86B1-8BB8-CE4E1B8B9A8D}"/>
              </a:ext>
            </a:extLst>
          </p:cNvPr>
          <p:cNvSpPr/>
          <p:nvPr/>
        </p:nvSpPr>
        <p:spPr>
          <a:xfrm rot="13332167" flipH="1">
            <a:off x="6148821" y="3765980"/>
            <a:ext cx="830998" cy="50592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E7241C9-AED4-67A1-35D0-DEB7CFE08837}"/>
              </a:ext>
            </a:extLst>
          </p:cNvPr>
          <p:cNvSpPr txBox="1"/>
          <p:nvPr/>
        </p:nvSpPr>
        <p:spPr>
          <a:xfrm>
            <a:off x="216747" y="121921"/>
            <a:ext cx="3447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6FA9D68-D384-BBEF-BF78-FEEA0A9142E2}"/>
              </a:ext>
            </a:extLst>
          </p:cNvPr>
          <p:cNvSpPr txBox="1"/>
          <p:nvPr/>
        </p:nvSpPr>
        <p:spPr>
          <a:xfrm>
            <a:off x="1805850" y="5489216"/>
            <a:ext cx="40098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40.9% in the systemic therapy group</a:t>
            </a:r>
          </a:p>
          <a:p>
            <a: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46.7% in the LAT group </a:t>
            </a:r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1E7BDDD-3406-3A6B-28F7-A38D89DB7CAB}"/>
              </a:ext>
            </a:extLst>
          </p:cNvPr>
          <p:cNvSpPr txBox="1"/>
          <p:nvPr/>
        </p:nvSpPr>
        <p:spPr>
          <a:xfrm>
            <a:off x="4651192" y="6039036"/>
            <a:ext cx="917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=0.78</a:t>
            </a:r>
            <a:endParaRPr kumimoji="1" lang="ja-JP" altLang="en-US" sz="14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92626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59</Words>
  <Application>Microsoft Office PowerPoint</Application>
  <PresentationFormat>ワイド画面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大亮 森永</dc:creator>
  <cp:lastModifiedBy>大亮 森永</cp:lastModifiedBy>
  <cp:revision>14</cp:revision>
  <dcterms:created xsi:type="dcterms:W3CDTF">2024-11-20T06:15:37Z</dcterms:created>
  <dcterms:modified xsi:type="dcterms:W3CDTF">2024-12-30T06:35:56Z</dcterms:modified>
</cp:coreProperties>
</file>